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339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33339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"/>
          <p:cNvGraphicFramePr/>
          <p:nvPr/>
        </p:nvGraphicFramePr>
        <p:xfrm>
          <a:off x="793800" y="1523880"/>
          <a:ext cx="6508800" cy="4343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3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93800" y="1523880"/>
                    <a:ext cx="6508800" cy="4343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0" name=""/>
          <p:cNvSpPr/>
          <p:nvPr/>
        </p:nvSpPr>
        <p:spPr>
          <a:xfrm>
            <a:off x="7086600" y="2666880"/>
            <a:ext cx="1981080" cy="2593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E</a:t>
            </a:r>
            <a:r>
              <a:rPr b="0" lang="en-US" sz="1600" spc="-1" strike="noStrike" baseline="-25000">
                <a:solidFill>
                  <a:srgbClr val="000000"/>
                </a:solidFill>
                <a:latin typeface="Arial"/>
              </a:rPr>
              <a:t>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olid: unvaccinate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ashed: vaccinate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"/>
          <p:cNvSpPr/>
          <p:nvPr/>
        </p:nvSpPr>
        <p:spPr>
          <a:xfrm>
            <a:off x="7315200" y="3238560"/>
            <a:ext cx="533520" cy="1440"/>
          </a:xfrm>
          <a:prstGeom prst="line">
            <a:avLst/>
          </a:prstGeom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531200" y="3200400"/>
            <a:ext cx="75960" cy="76320"/>
          </a:xfrm>
          <a:prstGeom prst="ellipse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7315200" y="3619440"/>
            <a:ext cx="533520" cy="1800"/>
          </a:xfrm>
          <a:prstGeom prst="line">
            <a:avLst/>
          </a:prstGeom>
          <a:ln w="93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531200" y="3581280"/>
            <a:ext cx="75960" cy="76320"/>
          </a:xfrm>
          <a:prstGeom prst="ellipse">
            <a:avLst/>
          </a:prstGeom>
          <a:solidFill>
            <a:srgbClr val="ffcc00"/>
          </a:solidFill>
          <a:ln w="93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7315200" y="3975120"/>
            <a:ext cx="533520" cy="144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7531200" y="3936960"/>
            <a:ext cx="7596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315200" y="4305240"/>
            <a:ext cx="533520" cy="18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531200" y="4267080"/>
            <a:ext cx="75960" cy="763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851200" y="5715000"/>
            <a:ext cx="2590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ccine Coverage (%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-1202400" y="3183840"/>
            <a:ext cx="3809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verage Incidence  (Cases/1000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295280" y="1386000"/>
            <a:ext cx="114300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VE</a:t>
            </a:r>
            <a:r>
              <a:rPr b="0" lang="en-US" sz="1800" spc="-1" strike="noStrike" baseline="-25000">
                <a:solidFill>
                  <a:srgbClr val="333399"/>
                </a:solidFill>
                <a:latin typeface="Arial"/>
              </a:rPr>
              <a:t>S</a:t>
            </a: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=0.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12T23:43:03Z</dcterms:created>
  <dc:creator>nshenvi</dc:creator>
  <dc:description/>
  <dc:language>en-US</dc:language>
  <cp:lastModifiedBy>longini</cp:lastModifiedBy>
  <dcterms:modified xsi:type="dcterms:W3CDTF">2007-09-25T23:32:54Z</dcterms:modified>
  <cp:revision>298</cp:revision>
  <dc:subject/>
  <dc:title>Slide 1</dc:title>
</cp:coreProperties>
</file>